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1" r:id="rId3"/>
    <p:sldId id="262" r:id="rId4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FDC801B-CE13-480D-8BE6-781A9FE6A8B0}" v="4" dt="2020-07-05T04:27:04.0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94640"/>
  </p:normalViewPr>
  <p:slideViewPr>
    <p:cSldViewPr snapToGrid="0" snapToObjects="1">
      <p:cViewPr varScale="1">
        <p:scale>
          <a:sx n="101" d="100"/>
          <a:sy n="101" d="100"/>
        </p:scale>
        <p:origin x="294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zuta Satoshi" userId="29a9164ecf10307e" providerId="LiveId" clId="{DFDC801B-CE13-480D-8BE6-781A9FE6A8B0}"/>
    <pc:docChg chg="undo custSel modSld">
      <pc:chgData name="Shizuta Satoshi" userId="29a9164ecf10307e" providerId="LiveId" clId="{DFDC801B-CE13-480D-8BE6-781A9FE6A8B0}" dt="2020-07-05T04:27:04.063" v="29" actId="207"/>
      <pc:docMkLst>
        <pc:docMk/>
      </pc:docMkLst>
      <pc:sldChg chg="addSp modSp mod">
        <pc:chgData name="Shizuta Satoshi" userId="29a9164ecf10307e" providerId="LiveId" clId="{DFDC801B-CE13-480D-8BE6-781A9FE6A8B0}" dt="2020-07-05T04:27:04.063" v="29" actId="207"/>
        <pc:sldMkLst>
          <pc:docMk/>
          <pc:sldMk cId="2110424045" sldId="262"/>
        </pc:sldMkLst>
        <pc:spChg chg="add mod">
          <ac:chgData name="Shizuta Satoshi" userId="29a9164ecf10307e" providerId="LiveId" clId="{DFDC801B-CE13-480D-8BE6-781A9FE6A8B0}" dt="2020-07-05T04:27:04.063" v="29" actId="207"/>
          <ac:spMkLst>
            <pc:docMk/>
            <pc:sldMk cId="2110424045" sldId="262"/>
            <ac:spMk id="11" creationId="{CB8DDDD0-6A13-4F79-B368-7630DB04926D}"/>
          </ac:spMkLst>
        </pc:spChg>
        <pc:spChg chg="mod">
          <ac:chgData name="Shizuta Satoshi" userId="29a9164ecf10307e" providerId="LiveId" clId="{DFDC801B-CE13-480D-8BE6-781A9FE6A8B0}" dt="2020-07-05T04:26:40.428" v="2" actId="1076"/>
          <ac:spMkLst>
            <pc:docMk/>
            <pc:sldMk cId="2110424045" sldId="262"/>
            <ac:spMk id="3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788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035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8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112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65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852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226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04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24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47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51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026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747499"/>
              </p:ext>
            </p:extLst>
          </p:nvPr>
        </p:nvGraphicFramePr>
        <p:xfrm>
          <a:off x="12700" y="4279806"/>
          <a:ext cx="4463882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1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9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0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1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1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.9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.9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269531"/>
              </p:ext>
            </p:extLst>
          </p:nvPr>
        </p:nvGraphicFramePr>
        <p:xfrm>
          <a:off x="4622800" y="4279806"/>
          <a:ext cx="4456450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580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 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0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1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9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1" name="タイトル 1"/>
          <p:cNvSpPr txBox="1">
            <a:spLocks/>
          </p:cNvSpPr>
          <p:nvPr/>
        </p:nvSpPr>
        <p:spPr bwMode="auto">
          <a:xfrm>
            <a:off x="5623658" y="947220"/>
            <a:ext cx="3177442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Cardiovascular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death</a:t>
            </a:r>
          </a:p>
        </p:txBody>
      </p:sp>
      <p:sp>
        <p:nvSpPr>
          <p:cNvPr id="36" name="タイトル 1"/>
          <p:cNvSpPr txBox="1">
            <a:spLocks/>
          </p:cNvSpPr>
          <p:nvPr/>
        </p:nvSpPr>
        <p:spPr bwMode="auto">
          <a:xfrm>
            <a:off x="1236133" y="937204"/>
            <a:ext cx="2810934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All-cause death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13957" y="813328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A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961652" y="8133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>
                <a:latin typeface="Times New Roman"/>
                <a:cs typeface="Times New Roman"/>
              </a:rPr>
              <a:t>B</a:t>
            </a:r>
            <a:r>
              <a:rPr kumimoji="1" lang="en-US" altLang="ja-JP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26793" y="238145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/>
                <a:cs typeface="Times New Roman"/>
              </a:rPr>
              <a:t>S6 </a:t>
            </a:r>
            <a:r>
              <a:rPr kumimoji="1" lang="en-US" altLang="ja-JP">
                <a:latin typeface="Times New Roman"/>
                <a:cs typeface="Times New Roman"/>
              </a:rPr>
              <a:t>Fig.</a:t>
            </a:r>
            <a:endParaRPr kumimoji="1" lang="en-US" altLang="ja-JP" dirty="0">
              <a:latin typeface="Times New Roman"/>
              <a:cs typeface="Times New Roman"/>
            </a:endParaRPr>
          </a:p>
        </p:txBody>
      </p:sp>
      <p:pic>
        <p:nvPicPr>
          <p:cNvPr id="22" name="図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75" y="1214784"/>
            <a:ext cx="4406900" cy="2882900"/>
          </a:xfrm>
          <a:prstGeom prst="rect">
            <a:avLst/>
          </a:prstGeom>
        </p:spPr>
      </p:pic>
      <p:sp>
        <p:nvSpPr>
          <p:cNvPr id="23" name="テキスト ボックス 22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588888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</a:t>
            </a:r>
            <a:r>
              <a:rPr kumimoji="1"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236133" y="1401982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28" name="図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1749" y="1539176"/>
            <a:ext cx="215900" cy="419100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27826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5697" y="1214784"/>
            <a:ext cx="4330700" cy="2882900"/>
          </a:xfrm>
          <a:prstGeom prst="rect">
            <a:avLst/>
          </a:prstGeom>
        </p:spPr>
      </p:pic>
      <p:sp>
        <p:nvSpPr>
          <p:cNvPr id="35" name="テキスト ボックス 34"/>
          <p:cNvSpPr txBox="1"/>
          <p:nvPr/>
        </p:nvSpPr>
        <p:spPr>
          <a:xfrm>
            <a:off x="5942577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293157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0</a:t>
            </a:r>
            <a:r>
              <a:rPr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788758" y="1401982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341979" y="38629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pic>
        <p:nvPicPr>
          <p:cNvPr id="45" name="図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4374" y="1539176"/>
            <a:ext cx="215900" cy="41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0068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6778497"/>
              </p:ext>
            </p:extLst>
          </p:nvPr>
        </p:nvGraphicFramePr>
        <p:xfrm>
          <a:off x="12700" y="4279806"/>
          <a:ext cx="4463882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1.7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7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5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87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7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.1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2.7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2180250"/>
              </p:ext>
            </p:extLst>
          </p:nvPr>
        </p:nvGraphicFramePr>
        <p:xfrm>
          <a:off x="4622800" y="4279806"/>
          <a:ext cx="4456450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580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0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1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4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pic>
        <p:nvPicPr>
          <p:cNvPr id="30" name="図 2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07" y="1204460"/>
            <a:ext cx="4406900" cy="2882900"/>
          </a:xfrm>
          <a:prstGeom prst="rect">
            <a:avLst/>
          </a:prstGeom>
        </p:spPr>
      </p:pic>
      <p:sp>
        <p:nvSpPr>
          <p:cNvPr id="34" name="タイトル 1"/>
          <p:cNvSpPr txBox="1">
            <a:spLocks/>
          </p:cNvSpPr>
          <p:nvPr/>
        </p:nvSpPr>
        <p:spPr bwMode="auto">
          <a:xfrm>
            <a:off x="899058" y="937204"/>
            <a:ext cx="3410715" cy="261245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Heart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failure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hospitalization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588888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</a:t>
            </a:r>
            <a:r>
              <a:rPr kumimoji="1"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236133" y="1401982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40" name="図 3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1749" y="1539176"/>
            <a:ext cx="215900" cy="419100"/>
          </a:xfrm>
          <a:prstGeom prst="rect">
            <a:avLst/>
          </a:prstGeom>
        </p:spPr>
      </p:pic>
      <p:sp>
        <p:nvSpPr>
          <p:cNvPr id="41" name="テキスト ボックス 40"/>
          <p:cNvSpPr txBox="1"/>
          <p:nvPr/>
        </p:nvSpPr>
        <p:spPr>
          <a:xfrm>
            <a:off x="313957" y="8133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C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769720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pic>
        <p:nvPicPr>
          <p:cNvPr id="44" name="図 4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05372" y="1204460"/>
            <a:ext cx="4330700" cy="2882900"/>
          </a:xfrm>
          <a:prstGeom prst="rect">
            <a:avLst/>
          </a:prstGeom>
        </p:spPr>
      </p:pic>
      <p:sp>
        <p:nvSpPr>
          <p:cNvPr id="45" name="タイトル 1"/>
          <p:cNvSpPr txBox="1">
            <a:spLocks/>
          </p:cNvSpPr>
          <p:nvPr/>
        </p:nvSpPr>
        <p:spPr bwMode="auto">
          <a:xfrm>
            <a:off x="5623658" y="947220"/>
            <a:ext cx="3177442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Ischemic stroke</a:t>
            </a: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942577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6293157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=</a:t>
            </a:r>
            <a:r>
              <a:rPr kumimoji="1" lang="en-US" altLang="ja-JP" dirty="0">
                <a:latin typeface="Times New Roman"/>
                <a:cs typeface="Times New Roman"/>
              </a:rPr>
              <a:t>0.00</a:t>
            </a:r>
            <a:r>
              <a:rPr lang="en-US" altLang="ja-JP" dirty="0">
                <a:latin typeface="Times New Roman"/>
                <a:cs typeface="Times New Roman"/>
              </a:rPr>
              <a:t>4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788758" y="1401982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49" name="図 4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4374" y="1539176"/>
            <a:ext cx="215900" cy="419100"/>
          </a:xfrm>
          <a:prstGeom prst="rect">
            <a:avLst/>
          </a:prstGeom>
        </p:spPr>
      </p:pic>
      <p:sp>
        <p:nvSpPr>
          <p:cNvPr id="50" name="テキスト ボックス 49"/>
          <p:cNvSpPr txBox="1"/>
          <p:nvPr/>
        </p:nvSpPr>
        <p:spPr>
          <a:xfrm>
            <a:off x="7329020" y="38629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4961652" y="813328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D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115844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8903139"/>
              </p:ext>
            </p:extLst>
          </p:nvPr>
        </p:nvGraphicFramePr>
        <p:xfrm>
          <a:off x="12700" y="4279806"/>
          <a:ext cx="4463882" cy="15259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 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4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0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4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5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8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9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6" name="タイトル 1"/>
          <p:cNvSpPr txBox="1">
            <a:spLocks/>
          </p:cNvSpPr>
          <p:nvPr/>
        </p:nvSpPr>
        <p:spPr bwMode="auto">
          <a:xfrm>
            <a:off x="899058" y="937204"/>
            <a:ext cx="3410715" cy="261245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Major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bleeding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13957" y="813328"/>
            <a:ext cx="392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ja-JP" dirty="0">
                <a:latin typeface="Times New Roman"/>
                <a:cs typeface="Times New Roman"/>
              </a:rPr>
              <a:t>E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024" y="1208773"/>
            <a:ext cx="4330700" cy="2882900"/>
          </a:xfrm>
          <a:prstGeom prst="rect">
            <a:avLst/>
          </a:prstGeom>
        </p:spPr>
      </p:pic>
      <p:sp>
        <p:nvSpPr>
          <p:cNvPr id="22" name="テキスト ボックス 21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646596" y="2446409"/>
            <a:ext cx="17637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=</a:t>
            </a:r>
            <a:r>
              <a:rPr kumimoji="1" lang="en-US" altLang="ja-JP" dirty="0">
                <a:latin typeface="Times New Roman"/>
                <a:cs typeface="Times New Roman"/>
              </a:rPr>
              <a:t>0.22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236133" y="1401982"/>
            <a:ext cx="1050989" cy="629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WRF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28" name="図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1749" y="1539176"/>
            <a:ext cx="215900" cy="419100"/>
          </a:xfrm>
          <a:prstGeom prst="rect">
            <a:avLst/>
          </a:prstGeom>
        </p:spPr>
      </p:pic>
      <p:sp>
        <p:nvSpPr>
          <p:cNvPr id="29" name="テキスト ボックス 28"/>
          <p:cNvSpPr txBox="1"/>
          <p:nvPr/>
        </p:nvSpPr>
        <p:spPr>
          <a:xfrm>
            <a:off x="2769720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104240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475</Words>
  <Application>Microsoft Office PowerPoint</Application>
  <PresentationFormat>On-screen Show (4:3)</PresentationFormat>
  <Paragraphs>28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ホワイ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治 徹真</dc:creator>
  <cp:lastModifiedBy>chn off31</cp:lastModifiedBy>
  <cp:revision>14</cp:revision>
  <dcterms:created xsi:type="dcterms:W3CDTF">2018-09-18T08:51:15Z</dcterms:created>
  <dcterms:modified xsi:type="dcterms:W3CDTF">2020-10-31T10:19:45Z</dcterms:modified>
</cp:coreProperties>
</file>